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52" d="100"/>
          <a:sy n="52" d="100"/>
        </p:scale>
        <p:origin x="-102" y="-41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F113B2F3-3484-46AF-B7D5-C4A54B7586CE}" type="datetimeFigureOut">
              <a:rPr lang="en-CA" smtClean="0"/>
              <a:t>2018-1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2601145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F113B2F3-3484-46AF-B7D5-C4A54B7586CE}" type="datetimeFigureOut">
              <a:rPr lang="en-CA" smtClean="0"/>
              <a:t>2018-1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2211712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F113B2F3-3484-46AF-B7D5-C4A54B7586CE}" type="datetimeFigureOut">
              <a:rPr lang="en-CA" smtClean="0"/>
              <a:t>2018-1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3915185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F113B2F3-3484-46AF-B7D5-C4A54B7586CE}" type="datetimeFigureOut">
              <a:rPr lang="en-CA" smtClean="0"/>
              <a:t>2018-1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34132921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113B2F3-3484-46AF-B7D5-C4A54B7586CE}" type="datetimeFigureOut">
              <a:rPr lang="en-CA" smtClean="0"/>
              <a:t>2018-1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11626754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F113B2F3-3484-46AF-B7D5-C4A54B7586CE}" type="datetimeFigureOut">
              <a:rPr lang="en-CA" smtClean="0"/>
              <a:t>2018-1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26883552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F113B2F3-3484-46AF-B7D5-C4A54B7586CE}" type="datetimeFigureOut">
              <a:rPr lang="en-CA" smtClean="0"/>
              <a:t>2018-11-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27041673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F113B2F3-3484-46AF-B7D5-C4A54B7586CE}" type="datetimeFigureOut">
              <a:rPr lang="en-CA" smtClean="0"/>
              <a:t>2018-11-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3262816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13B2F3-3484-46AF-B7D5-C4A54B7586CE}" type="datetimeFigureOut">
              <a:rPr lang="en-CA" smtClean="0"/>
              <a:t>2018-11-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1076058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113B2F3-3484-46AF-B7D5-C4A54B7586CE}" type="datetimeFigureOut">
              <a:rPr lang="en-CA" smtClean="0"/>
              <a:t>2018-1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4026925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113B2F3-3484-46AF-B7D5-C4A54B7586CE}" type="datetimeFigureOut">
              <a:rPr lang="en-CA" smtClean="0"/>
              <a:t>2018-1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553A8B0-7A21-43E3-BF48-FBD109DEF981}" type="slidenum">
              <a:rPr lang="en-CA" smtClean="0"/>
              <a:t>‹#›</a:t>
            </a:fld>
            <a:endParaRPr lang="en-CA"/>
          </a:p>
        </p:txBody>
      </p:sp>
    </p:spTree>
    <p:extLst>
      <p:ext uri="{BB962C8B-B14F-4D97-AF65-F5344CB8AC3E}">
        <p14:creationId xmlns:p14="http://schemas.microsoft.com/office/powerpoint/2010/main" val="26144142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113B2F3-3484-46AF-B7D5-C4A54B7586CE}" type="datetimeFigureOut">
              <a:rPr lang="en-CA" smtClean="0"/>
              <a:t>2018-11-19</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553A8B0-7A21-43E3-BF48-FBD109DEF981}" type="slidenum">
              <a:rPr lang="en-CA" smtClean="0"/>
              <a:t>‹#›</a:t>
            </a:fld>
            <a:endParaRPr lang="en-CA"/>
          </a:p>
        </p:txBody>
      </p:sp>
    </p:spTree>
    <p:extLst>
      <p:ext uri="{BB962C8B-B14F-4D97-AF65-F5344CB8AC3E}">
        <p14:creationId xmlns:p14="http://schemas.microsoft.com/office/powerpoint/2010/main" val="29301778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07504" y="2708920"/>
            <a:ext cx="8928992" cy="1384995"/>
          </a:xfrm>
          <a:prstGeom prst="rect">
            <a:avLst/>
          </a:prstGeom>
        </p:spPr>
        <p:txBody>
          <a:bodyPr wrap="square">
            <a:spAutoFit/>
          </a:bodyPr>
          <a:lstStyle/>
          <a:p>
            <a:r>
              <a:rPr lang="en-CA" sz="1200" dirty="0" smtClean="0"/>
              <a:t>Online Resource 2. Percent of population classified as more susceptible to adverse effects of air pollution by health region according to inclusive criteria. Insets show detail for southern Alberta and southern Ontario; health regions outlined in bold are in the highest quartile of percent susceptible according to restrictive and/or inclusive criteria and highest quartile of PM2.5 and/or O3.</a:t>
            </a:r>
          </a:p>
          <a:p>
            <a:endParaRPr lang="en-CA" sz="1200" dirty="0" smtClean="0"/>
          </a:p>
          <a:p>
            <a:r>
              <a:rPr lang="en-CA" sz="1200" dirty="0"/>
              <a:t>Stieb DM*, Yao J, Henderson SB, Pinault L, Smith-Doiron MH, Robichaud A, van Donkelaar A, Martin RV, Ménard R, Brook JR. Variability in ambient ozone and fine particle concentrations and population susceptibility among Canadian health regions. Can J Public Health </a:t>
            </a:r>
          </a:p>
          <a:p>
            <a:r>
              <a:rPr lang="en-CA" sz="1200"/>
              <a:t>*corresponding author, Health Canada and School of Epidemiology and Public Health, University of Ottawa, dave.stieb@canada.ca</a:t>
            </a:r>
            <a:endParaRPr lang="en-CA" sz="1200" dirty="0"/>
          </a:p>
        </p:txBody>
      </p:sp>
    </p:spTree>
    <p:extLst>
      <p:ext uri="{BB962C8B-B14F-4D97-AF65-F5344CB8AC3E}">
        <p14:creationId xmlns:p14="http://schemas.microsoft.com/office/powerpoint/2010/main" val="15946431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03806" y="143296"/>
            <a:ext cx="8272650" cy="6598072"/>
          </a:xfrm>
          <a:prstGeom prst="rect">
            <a:avLst/>
          </a:prstGeom>
        </p:spPr>
      </p:pic>
    </p:spTree>
    <p:extLst>
      <p:ext uri="{BB962C8B-B14F-4D97-AF65-F5344CB8AC3E}">
        <p14:creationId xmlns:p14="http://schemas.microsoft.com/office/powerpoint/2010/main" val="16503549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TotalTime>
  <Words>132</Words>
  <Application>Microsoft Office PowerPoint</Application>
  <PresentationFormat>On-screen Show (4:3)</PresentationFormat>
  <Paragraphs>4</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Health Canada - Santé Canada</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e Stieb</dc:creator>
  <cp:lastModifiedBy>Dave Stieb</cp:lastModifiedBy>
  <cp:revision>2</cp:revision>
  <dcterms:created xsi:type="dcterms:W3CDTF">2018-06-25T19:19:35Z</dcterms:created>
  <dcterms:modified xsi:type="dcterms:W3CDTF">2018-11-20T05:16:07Z</dcterms:modified>
</cp:coreProperties>
</file>